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35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E3183-801F-419C-A855-A598DDDC83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0239C2-2EFE-474A-B573-131FA63014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B90473-AB47-4A12-9836-C8A251624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E09D80-8139-4E42-8532-0AA80E120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39CC3E-94B4-4935-82EE-4D0435DAF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965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C1307-5A80-4604-B300-BCBEECFA00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BD4692-A904-444E-B984-7733DA3314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77843E-1777-4D97-BEED-3468F9539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A93AE-DD7B-4D7A-857F-1DF1731CA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C028A2-9FF4-4B21-B880-25118B2CF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0639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567E18-2850-4B83-B5DA-CA7C57BC3D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545A8C-924B-43FB-8FCA-435276C42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5533A8-40F6-4DED-A075-69A2932B6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D17336-C4C2-4B5F-98E8-417E2732D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E195D-CC59-417F-B22C-B7FFEB765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893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27455-D28B-46A2-835D-5D513E6C8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9D112B-7BF8-49BF-886A-E715BA348B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9A845D-4DDA-4075-94CA-AC89CE7F5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BD51C0-5A1A-40E1-86DE-3ACC278E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1E2BA-A23F-4310-B6B5-343F6D233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908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4C68DD-7114-420A-9D3D-0C064228C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6AE924-9EE6-44F4-8FF2-1EFAAC5A5D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2AC6A-FE04-436E-887D-32D007C8B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30C60-BFAC-4541-BCDA-15EDB5CD4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61B995-2A8A-4CB7-B78A-3C884AF03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61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81EEA-A81A-403B-9FB6-571C966BFF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08F840-0629-4EB0-B472-F25F391CC1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2FD225-407A-4D0D-9A5E-0B93EF67FF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B1347C-7BF3-456A-A5E5-B0A87D5E9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5B7B3B-9F2D-4238-86B6-01F2049CC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E18D67-9CCA-4070-9D14-CDAA7DBF0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249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994F5-8395-4813-B5F9-05ACE06DF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5531D9-2717-4433-BA7A-0C4397BEFC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CD22BC-FFA2-4AE0-9F9C-40D807E4C5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2F15F5-1B70-402B-A626-65B551244F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07DD63-5BED-48B5-92A5-C1EDDF80C2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1C13C4-3E13-467D-ACDE-42698D239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3FA5EA-34B4-4B85-B69B-55DC9D6FF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BB076C5-15D1-46D8-8F1B-AA5D31AE6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732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C7825-830E-4150-B19C-1AD90315FE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A808CF-A30A-439D-8102-41B33712D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7BDD8B-9352-476A-9AB9-022B1048F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D4CD4C-B1EC-48A4-8793-DC157253F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919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8F722F-C681-422C-B14F-951C36B17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8A5392-B301-48EC-8E97-07848C9AE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388B5D-AEB2-48A8-9D6F-6F4593B67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581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8D9B85-9543-4E74-8AE5-EFB554B24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35C9F7-90DA-42EF-BB44-B0B756DD70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221514-5D0C-4F32-BBD6-4D007F84C3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127EB1-2602-473E-B024-B1D17DE85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2D8424-4693-4419-B46D-996DF62C0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9D45AE-9585-4C60-8677-1A0D0D986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34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EBCB9-83C0-4352-B4BF-37A299D15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D88CEA-55F4-460B-996E-515CFC86FA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478439-766A-437B-ADF0-0CFBA733A3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1A37F8-C79A-45E9-A949-DEFB2B3EF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900CF9-2138-451C-BB7B-2846C02B4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421F86-66F9-48B3-9FA9-477B55D52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971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B50AF5-03B7-4699-8EEA-AEF595FC1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9648D2-475A-4A69-B504-9F3690BE85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0D0BF1-9588-40CE-9224-9A6A2DEA34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B6D07-347A-4CAA-8BBD-E0C15DA329E7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113490-6C5A-48DB-A718-90B3D58CFA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3DBF17-4A15-435B-A3EA-B38AA9C7D1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E0003-9607-4681-8C22-7EE1744759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3379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DECC3-159C-4BDF-B2BF-55FDEB3BC35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98244A-9460-4C36-AB1F-4D937F72AC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4AF76B-097D-4EB1-A3A2-A1CAE0FD14EF}"/>
              </a:ext>
            </a:extLst>
          </p:cNvPr>
          <p:cNvSpPr txBox="1"/>
          <p:nvPr/>
        </p:nvSpPr>
        <p:spPr>
          <a:xfrm>
            <a:off x="1105763" y="5961065"/>
            <a:ext cx="92495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Figure 8</a:t>
            </a:r>
            <a:r>
              <a:rPr lang="en-GB" sz="1100" dirty="0"/>
              <a:t>: Location of resistance QTL on the</a:t>
            </a:r>
            <a:r>
              <a:rPr lang="en-GB" sz="1100" b="1" dirty="0"/>
              <a:t> </a:t>
            </a:r>
            <a:r>
              <a:rPr lang="en-GB" sz="1100" dirty="0"/>
              <a:t>Armenian </a:t>
            </a:r>
            <a:r>
              <a:rPr lang="en-GB" sz="1100" i="1" dirty="0"/>
              <a:t>L. serriola</a:t>
            </a:r>
            <a:r>
              <a:rPr lang="en-GB" sz="1100" dirty="0"/>
              <a:t> x PI251246 marker density map. Horizontal bars show the 1.5 LOD confidence interval of the QTL loci and the vertical bar shows the location of the peak QTL marker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895E34A-83CD-452B-B713-A5B43871A5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91"/>
          <a:stretch/>
        </p:blipFill>
        <p:spPr>
          <a:xfrm rot="16200000">
            <a:off x="3466356" y="-2665450"/>
            <a:ext cx="5070686" cy="1133368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324F901-3B41-4B45-9D81-83FD07FA3D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10531440" y="767822"/>
            <a:ext cx="897646" cy="428234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4FA662B-66C1-40AB-9D6D-EA333BDF7AD0}"/>
              </a:ext>
            </a:extLst>
          </p:cNvPr>
          <p:cNvSpPr txBox="1"/>
          <p:nvPr/>
        </p:nvSpPr>
        <p:spPr>
          <a:xfrm>
            <a:off x="1758190" y="5176598"/>
            <a:ext cx="36717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CD89B13-5F8F-4531-A44F-B03A053FDDF9}"/>
              </a:ext>
            </a:extLst>
          </p:cNvPr>
          <p:cNvSpPr txBox="1"/>
          <p:nvPr/>
        </p:nvSpPr>
        <p:spPr>
          <a:xfrm>
            <a:off x="2432516" y="5176598"/>
            <a:ext cx="36717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9B4DBA0-B644-4576-9B4F-0B3BC5BE4004}"/>
              </a:ext>
            </a:extLst>
          </p:cNvPr>
          <p:cNvSpPr txBox="1"/>
          <p:nvPr/>
        </p:nvSpPr>
        <p:spPr>
          <a:xfrm>
            <a:off x="3106842" y="5176598"/>
            <a:ext cx="36717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8863B3-8C8E-47F2-917A-4DD702710ECF}"/>
              </a:ext>
            </a:extLst>
          </p:cNvPr>
          <p:cNvSpPr txBox="1"/>
          <p:nvPr/>
        </p:nvSpPr>
        <p:spPr>
          <a:xfrm>
            <a:off x="3787589" y="5173670"/>
            <a:ext cx="36717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F9C3AF7-A78D-41D5-AABA-5751E86A9CFC}"/>
              </a:ext>
            </a:extLst>
          </p:cNvPr>
          <p:cNvSpPr txBox="1"/>
          <p:nvPr/>
        </p:nvSpPr>
        <p:spPr>
          <a:xfrm>
            <a:off x="4426292" y="5173670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AC1B00-4991-4AD1-B7F0-54307B426103}"/>
              </a:ext>
            </a:extLst>
          </p:cNvPr>
          <p:cNvSpPr txBox="1"/>
          <p:nvPr/>
        </p:nvSpPr>
        <p:spPr>
          <a:xfrm>
            <a:off x="5104149" y="5173669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405DB3-F7AD-40DA-8A1E-9BC361749C5F}"/>
              </a:ext>
            </a:extLst>
          </p:cNvPr>
          <p:cNvSpPr txBox="1"/>
          <p:nvPr/>
        </p:nvSpPr>
        <p:spPr>
          <a:xfrm>
            <a:off x="5785850" y="5181365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BB58ABA-45CA-40EA-9AED-20EDD7314E77}"/>
              </a:ext>
            </a:extLst>
          </p:cNvPr>
          <p:cNvSpPr txBox="1"/>
          <p:nvPr/>
        </p:nvSpPr>
        <p:spPr>
          <a:xfrm>
            <a:off x="7140610" y="5173667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24AFDD1-B89E-4BB5-A7BA-AE2353E7D0A9}"/>
              </a:ext>
            </a:extLst>
          </p:cNvPr>
          <p:cNvSpPr txBox="1"/>
          <p:nvPr/>
        </p:nvSpPr>
        <p:spPr>
          <a:xfrm>
            <a:off x="6462859" y="5168867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96CDF2B-0610-4BD2-84F1-D17A0B0A9F95}"/>
              </a:ext>
            </a:extLst>
          </p:cNvPr>
          <p:cNvSpPr txBox="1"/>
          <p:nvPr/>
        </p:nvSpPr>
        <p:spPr>
          <a:xfrm>
            <a:off x="7822104" y="5177517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171629A-CA6C-4435-BD0E-196CDD8747D3}"/>
              </a:ext>
            </a:extLst>
          </p:cNvPr>
          <p:cNvSpPr txBox="1"/>
          <p:nvPr/>
        </p:nvSpPr>
        <p:spPr>
          <a:xfrm>
            <a:off x="8499247" y="5182287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2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0F8D59F-B994-4088-8A18-5B3E2422AF3F}"/>
              </a:ext>
            </a:extLst>
          </p:cNvPr>
          <p:cNvSpPr txBox="1"/>
          <p:nvPr/>
        </p:nvSpPr>
        <p:spPr>
          <a:xfrm>
            <a:off x="9189735" y="5178119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387329-3DCD-4413-9442-90CD30AC77E3}"/>
              </a:ext>
            </a:extLst>
          </p:cNvPr>
          <p:cNvSpPr txBox="1"/>
          <p:nvPr/>
        </p:nvSpPr>
        <p:spPr>
          <a:xfrm>
            <a:off x="5553161" y="5336549"/>
            <a:ext cx="43841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M </a:t>
            </a:r>
          </a:p>
        </p:txBody>
      </p:sp>
    </p:spTree>
    <p:extLst>
      <p:ext uri="{BB962C8B-B14F-4D97-AF65-F5344CB8AC3E}">
        <p14:creationId xmlns:p14="http://schemas.microsoft.com/office/powerpoint/2010/main" val="1526298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58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10</cp:revision>
  <dcterms:created xsi:type="dcterms:W3CDTF">2021-04-11T17:16:07Z</dcterms:created>
  <dcterms:modified xsi:type="dcterms:W3CDTF">2022-02-20T16:04:57Z</dcterms:modified>
</cp:coreProperties>
</file>